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91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7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87F2A3-04E0-4E64-9C04-A3A845CA73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9662E9C-3F7B-478A-BCE2-A411E914A8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082DE7-517B-4334-A65F-78A15730A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0F7040-AE85-43D9-8308-9D9CEC56A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AA154D-66D8-4202-A1B7-194781D0B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451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9DFBBE-71AF-4D2F-8776-8826A493A1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6FB3B6-7B7D-4B80-9CC4-83A14F1ABA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C038D7-E520-48AF-9FF0-8F5705018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92FF8D-5659-41CA-8748-F95CB22E5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250FC0-F059-4D10-BA6F-615AF63C6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951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9DCB512-0D11-451C-B572-8302DDE3FE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2B4E88F-C66D-46C6-85A5-7B5A96C10E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E024ED-DDE5-4BFC-BB47-FD4EE06B7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360B0E-E833-437D-B4FC-B092DDA0C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B8C3E5-F89B-47A6-A8DC-3BFE1F8A0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6776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9DBFD5-A580-4AD9-A291-9E0EE670F5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7BAAE3-BD5F-48A0-89D4-007E645224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0E107E-8872-4215-A7E7-4AD817FDA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10E8BB-ED8A-42BA-9B2A-44695F74D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C161A8-D0CA-4A2C-A074-3235FADAC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596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B5E95B-D299-4609-AFBE-2272C64C57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3EB285-BC76-4140-AFD0-77BA528FE7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584CA0-71BE-47DA-9847-804DB2973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41C68A-31EB-421D-8DAC-FFF54705B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A30C31-81BB-49C2-82F9-57825462F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7428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A92D51-BBEC-4C1F-B1E9-C0AA44C274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60F307-C206-41C9-BB73-DCD1E5309F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BDB40D-1E89-47A7-BBAC-A825089209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E89DFA2-EFFF-4E8C-9FCA-6E2D92CF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E738115-55C6-4991-913D-E06C3CD70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383D2D-B37F-40DA-9944-E68018FE1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3545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FA33AB-2816-4887-A01D-D7738328B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E1AA1EF-9677-4598-9375-963BFE9372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7D7EC74-E61C-44A8-986A-23173E7DFD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FACF8CC-1D0B-45F4-AC71-0764920EAB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A0FD17B-BDA7-482C-9067-A4652E4EBC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81E68ED-7823-4D21-9AB5-ECFF1A11F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D18D073-8E83-4E65-BA2F-D1E770910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FD1057C-1D07-4E58-9C18-42C578163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430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DA51DC-83F5-482D-B497-BC4E1F28B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B82BC4C-06A6-4EB4-BE51-348CECC01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E60A9D7-65F2-4F50-A6D9-657E9B174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D6E744F-46D8-40AE-908F-DCBED79F5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604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B40BD64-2876-43EF-A205-C65193FDC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FE6BD86-E490-48DF-A0A5-8E11F1C58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86B93A-CFDD-4520-98EE-A094999E2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64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94A03-8605-4C9D-8BF5-EFF69408D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4298F33-683C-4567-A5D6-62F927684F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2EA7CF9-9A22-40BB-9502-A0F2D02F46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C682B5-7647-48B8-BCD4-E4DA5ADCB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0FF61D4-A368-44F0-81C3-93BAFD48C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4A40A6-949E-4385-9178-74B924273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0658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DE9AE0-BEA3-4CF1-939B-8467841C7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62BCBAA-4167-44E7-8960-CB93DDA639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E449013-A626-4AD5-B169-0E49FD5821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A607A9-3C21-407B-B482-066B7B0E3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D2BB02-9D6C-4126-BA3A-7C14478A2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AD94CB7-1CA0-47BE-BCB7-176AC5EF9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0714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82342AD-A553-48FC-8682-F2A6B4E2A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ED6815-4720-41F6-AEAB-3EC1D46C0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9A646E-0A0C-4DB6-82E2-70C2E35C31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09C69-4CBB-4852-A870-C75DEF27AABD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6C9B9E-A5D9-4D70-8DE3-8F702F8755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C59DEF-342B-4210-A757-8AAF4EC709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66767-39EA-46C6-AA8D-DBA7F04AD4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8966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309085D-4470-4E70-9F34-EB6B0044DC82}"/>
              </a:ext>
            </a:extLst>
          </p:cNvPr>
          <p:cNvSpPr txBox="1"/>
          <p:nvPr/>
        </p:nvSpPr>
        <p:spPr>
          <a:xfrm>
            <a:off x="606390" y="6143705"/>
            <a:ext cx="4810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design of the </a:t>
            </a:r>
            <a:r>
              <a:rPr kumimoji="1"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study participants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4AE47699-4C8F-4631-8155-8D559A1FF865}"/>
              </a:ext>
            </a:extLst>
          </p:cNvPr>
          <p:cNvSpPr/>
          <p:nvPr/>
        </p:nvSpPr>
        <p:spPr>
          <a:xfrm>
            <a:off x="625244" y="411164"/>
            <a:ext cx="1995549" cy="421185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ctr" defTabSz="457200">
              <a:defRPr/>
            </a:pP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tudy</a:t>
            </a:r>
            <a:r>
              <a: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endParaRPr kumimoji="0" lang="en-US" altLang="ja-JP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8F4AE99-D8E3-4D63-A9D4-4FA8E2B68C73}"/>
              </a:ext>
            </a:extLst>
          </p:cNvPr>
          <p:cNvCxnSpPr>
            <a:cxnSpLocks/>
          </p:cNvCxnSpPr>
          <p:nvPr/>
        </p:nvCxnSpPr>
        <p:spPr>
          <a:xfrm>
            <a:off x="1635886" y="844343"/>
            <a:ext cx="0" cy="3867733"/>
          </a:xfrm>
          <a:prstGeom prst="line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1F8EEB03-6FF2-4A1D-946A-C3235FB2B2E9}"/>
              </a:ext>
            </a:extLst>
          </p:cNvPr>
          <p:cNvSpPr/>
          <p:nvPr/>
        </p:nvSpPr>
        <p:spPr>
          <a:xfrm>
            <a:off x="2591549" y="944738"/>
            <a:ext cx="2567432" cy="1147350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just" defTabSz="457200"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following conditions were excluded.</a:t>
            </a:r>
          </a:p>
          <a:p>
            <a:pPr lvl="0" algn="just" defTabSz="457200">
              <a:defRPr/>
            </a:pP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 19 or younger</a:t>
            </a:r>
          </a:p>
          <a:p>
            <a:pPr lvl="0" algn="just" defTabSz="457200">
              <a:defRPr/>
            </a:pP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 or older</a:t>
            </a:r>
          </a:p>
          <a:p>
            <a:pPr lvl="0" algn="just" defTabSz="457200">
              <a:defRPr/>
            </a:pP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employed, officer (director, executive officer)</a:t>
            </a:r>
          </a:p>
          <a:p>
            <a:pPr lvl="0" algn="just" defTabSz="457200">
              <a:defRPr/>
            </a:pP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rking less than 2 days a week</a:t>
            </a:r>
          </a:p>
          <a:p>
            <a:pPr lvl="0" algn="just" defTabSz="457200"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response</a:t>
            </a: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2181E125-3549-4FD1-9882-746865442159}"/>
              </a:ext>
            </a:extLst>
          </p:cNvPr>
          <p:cNvCxnSpPr>
            <a:cxnSpLocks/>
          </p:cNvCxnSpPr>
          <p:nvPr/>
        </p:nvCxnSpPr>
        <p:spPr>
          <a:xfrm>
            <a:off x="1653896" y="1518413"/>
            <a:ext cx="955663" cy="0"/>
          </a:xfrm>
          <a:prstGeom prst="line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8" name="正方形/長方形 17"/>
          <p:cNvSpPr/>
          <p:nvPr/>
        </p:nvSpPr>
        <p:spPr>
          <a:xfrm>
            <a:off x="625244" y="2181164"/>
            <a:ext cx="1995549" cy="395390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ctr" defTabSz="457200">
              <a:defRPr/>
            </a:pP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tudy</a:t>
            </a:r>
            <a:r>
              <a: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out night shifts</a:t>
            </a:r>
            <a:endParaRPr kumimoji="0" lang="en-US" altLang="ja-JP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= 5534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2" name="直線コネクタ 21"/>
          <p:cNvCxnSpPr>
            <a:cxnSpLocks/>
          </p:cNvCxnSpPr>
          <p:nvPr/>
        </p:nvCxnSpPr>
        <p:spPr>
          <a:xfrm>
            <a:off x="1653896" y="2941007"/>
            <a:ext cx="955663" cy="0"/>
          </a:xfrm>
          <a:prstGeom prst="line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23" name="正方形/長方形 22"/>
          <p:cNvSpPr/>
          <p:nvPr/>
        </p:nvSpPr>
        <p:spPr>
          <a:xfrm>
            <a:off x="625244" y="3319127"/>
            <a:ext cx="1995549" cy="395390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ctr" defTabSz="457200">
              <a:defRPr/>
            </a:pP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tudy</a:t>
            </a:r>
            <a:r>
              <a: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r>
              <a:rPr kumimoji="0" lang="ja-JP" altLang="en-US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out night shifts</a:t>
            </a:r>
            <a:endParaRPr kumimoji="0" lang="en-US" altLang="ja-JP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=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726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2591549" y="2775036"/>
            <a:ext cx="2596678" cy="403353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just" defTabSz="457200"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s those who work night shifts (22:00 - 5:00)</a:t>
            </a:r>
          </a:p>
          <a:p>
            <a:pPr lvl="0" algn="just" defTabSz="457200"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 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= 808 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6" name="直線コネクタ 25"/>
          <p:cNvCxnSpPr>
            <a:cxnSpLocks/>
          </p:cNvCxnSpPr>
          <p:nvPr/>
        </p:nvCxnSpPr>
        <p:spPr>
          <a:xfrm>
            <a:off x="1635886" y="4196890"/>
            <a:ext cx="955663" cy="0"/>
          </a:xfrm>
          <a:prstGeom prst="line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27" name="正方形/長方形 26"/>
          <p:cNvSpPr/>
          <p:nvPr/>
        </p:nvSpPr>
        <p:spPr>
          <a:xfrm>
            <a:off x="2591549" y="3992706"/>
            <a:ext cx="1860415" cy="403353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just" defTabSz="457200"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people who miss breakfast.</a:t>
            </a:r>
          </a:p>
          <a:p>
            <a:pPr lvl="0" algn="just" defTabSz="457200"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 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= 452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593522" y="4712076"/>
            <a:ext cx="2058993" cy="509119"/>
          </a:xfrm>
          <a:prstGeom prst="rect">
            <a:avLst/>
          </a:prstGeom>
          <a:solidFill>
            <a:sysClr val="window" lastClr="FFFFFF"/>
          </a:solidFill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articipants included in the analysis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= </a:t>
            </a:r>
            <a:r>
              <a:rPr kumimoji="0" lang="en-US" altLang="ja-JP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74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0633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82</TotalTime>
  <Words>97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e-shinto-03</dc:creator>
  <cp:lastModifiedBy>MDPI</cp:lastModifiedBy>
  <cp:revision>131</cp:revision>
  <dcterms:created xsi:type="dcterms:W3CDTF">2021-07-01T03:44:57Z</dcterms:created>
  <dcterms:modified xsi:type="dcterms:W3CDTF">2022-12-06T02:56:16Z</dcterms:modified>
</cp:coreProperties>
</file>